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A4357D-4124-4EEA-BB74-C0D41E16561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2324BE-A297-41D7-AEA3-02F09E6D36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7575DD-1B3B-4242-A96E-5C0DCF58B5A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E627A6-308E-4290-801D-911ED277CE3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FBB2BD-C04A-4C3F-A419-A563DEA5A3C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ADCFD6-A3FA-418D-9C34-1F5B409042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A03A6B-1C00-4412-A10F-43BEAC11309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0D07D1-21AF-4CF0-86C1-5FD5471FE9A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0DB9F7-DC8E-4002-A765-DE23071F29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81C3D6-41D0-4940-8BB1-F06839B951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F50AEA-C9C0-4FD5-99E0-BFDE491A44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E816B3-D00F-4310-8007-D7A05C4A18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788A4B3-39ED-40B8-98D5-94038176C2AA}" type="slidenum">
              <a:rPr b="0" lang="he-IL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68"/>
          <p:cNvGrpSpPr/>
          <p:nvPr/>
        </p:nvGrpSpPr>
        <p:grpSpPr>
          <a:xfrm>
            <a:off x="2278080" y="684360"/>
            <a:ext cx="2303280" cy="3456000"/>
            <a:chOff x="2278080" y="684360"/>
            <a:chExt cx="2303280" cy="3456000"/>
          </a:xfrm>
        </p:grpSpPr>
        <p:pic>
          <p:nvPicPr>
            <p:cNvPr id="42" name="Picture 63" descr=""/>
            <p:cNvPicPr/>
            <p:nvPr/>
          </p:nvPicPr>
          <p:blipFill>
            <a:blip r:embed="rId1"/>
            <a:stretch/>
          </p:blipFill>
          <p:spPr>
            <a:xfrm>
              <a:off x="3449520" y="1116000"/>
              <a:ext cx="989280" cy="3024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64" descr=""/>
            <p:cNvPicPr/>
            <p:nvPr/>
          </p:nvPicPr>
          <p:blipFill>
            <a:blip r:embed="rId2"/>
            <a:stretch/>
          </p:blipFill>
          <p:spPr>
            <a:xfrm>
              <a:off x="2357280" y="1116000"/>
              <a:ext cx="982800" cy="3024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Text Box 65"/>
            <p:cNvSpPr/>
            <p:nvPr/>
          </p:nvSpPr>
          <p:spPr>
            <a:xfrm>
              <a:off x="2278080" y="684360"/>
              <a:ext cx="11523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rtl="1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At-cpn20</a:t>
              </a: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 Box 66"/>
            <p:cNvSpPr/>
            <p:nvPr/>
          </p:nvSpPr>
          <p:spPr>
            <a:xfrm>
              <a:off x="3430440" y="684360"/>
              <a:ext cx="11509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rtl="1"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Pf-cpn20</a:t>
              </a: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6" name="Rectangle 67"/>
          <p:cNvSpPr/>
          <p:nvPr/>
        </p:nvSpPr>
        <p:spPr>
          <a:xfrm>
            <a:off x="803160" y="4563720"/>
            <a:ext cx="49402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3: Aggregation of cpn20 following exposure to high temperature.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f-cpn20 and At-cpn20 were exposed to increasing temperatures (25 - 80 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o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)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 described.  The cuvette was photographed at the end of the experiment and 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s presented to allow visualization of the degree of aggregation.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0-21T13:04:23Z</dcterms:created>
  <dc:creator>AzemA4</dc:creator>
  <dc:description/>
  <dc:language>en-US</dc:language>
  <cp:lastModifiedBy>selest</cp:lastModifiedBy>
  <dcterms:modified xsi:type="dcterms:W3CDTF">2012-11-23T08:36:11Z</dcterms:modified>
  <cp:revision>17</cp:revision>
  <dc:subject/>
  <dc:title>Slide 1</dc:title>
</cp:coreProperties>
</file>